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03" d="100"/>
          <a:sy n="103" d="100"/>
        </p:scale>
        <p:origin x="-252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obinortiz:Documents:JH%20Research:Golden:5.23.17_Outliers%20removed_11.6.16_MinD%20copy_ALL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obinortiz:Documents:JH%20Research:Golden:5.23.17_Outliers%20removed_11.6.16_MinD%20copy_ALL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obinortiz:Documents:JH%20Research:Golden:5.23.17_Outliers%20removed_11.6.16_MinD%20copy_ALL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obinortiz:Documents:JH%20Research:Golden:5.23.17_Outliers%20removed_11.6.16_MinD%20copy_ALL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W$1</c:f>
              <c:strCache>
                <c:ptCount val="1"/>
                <c:pt idx="0">
                  <c:v>hFKint2Region4Pyro2CpG5</c:v>
                </c:pt>
              </c:strCache>
            </c:strRef>
          </c:tx>
          <c:spPr>
            <a:ln w="47625">
              <a:noFill/>
            </a:ln>
          </c:spPr>
          <c:trendline>
            <c:trendlineType val="linear"/>
            <c:dispRSqr val="1"/>
            <c:dispEq val="1"/>
            <c:trendlineLbl>
              <c:layout>
                <c:manualLayout>
                  <c:x val="0.12690223097112899"/>
                  <c:y val="0.65576224846894104"/>
                </c:manualLayout>
              </c:layout>
              <c:numFmt formatCode="General" sourceLinked="0"/>
            </c:trendlineLbl>
          </c:trendline>
          <c:xVal>
            <c:numRef>
              <c:f>Sheet1!$K$2:$K$129</c:f>
              <c:numCache>
                <c:formatCode>#.00</c:formatCode>
                <c:ptCount val="128"/>
                <c:pt idx="0">
                  <c:v>9.6999999999999993</c:v>
                </c:pt>
                <c:pt idx="1">
                  <c:v>11.4</c:v>
                </c:pt>
                <c:pt idx="2">
                  <c:v>6.7</c:v>
                </c:pt>
                <c:pt idx="3">
                  <c:v>11.3</c:v>
                </c:pt>
                <c:pt idx="4">
                  <c:v>8.6999999999999993</c:v>
                </c:pt>
                <c:pt idx="6">
                  <c:v>8.1999999999999993</c:v>
                </c:pt>
                <c:pt idx="7">
                  <c:v>7.6</c:v>
                </c:pt>
                <c:pt idx="8">
                  <c:v>8.6999999999999993</c:v>
                </c:pt>
                <c:pt idx="9">
                  <c:v>9.1</c:v>
                </c:pt>
                <c:pt idx="10">
                  <c:v>6.7</c:v>
                </c:pt>
                <c:pt idx="11">
                  <c:v>10</c:v>
                </c:pt>
                <c:pt idx="12">
                  <c:v>6.8</c:v>
                </c:pt>
                <c:pt idx="13">
                  <c:v>6.3</c:v>
                </c:pt>
                <c:pt idx="14">
                  <c:v>10.199999999999999</c:v>
                </c:pt>
                <c:pt idx="15">
                  <c:v>7.9</c:v>
                </c:pt>
                <c:pt idx="16">
                  <c:v>10.7</c:v>
                </c:pt>
                <c:pt idx="17">
                  <c:v>7.5</c:v>
                </c:pt>
                <c:pt idx="18">
                  <c:v>6.9</c:v>
                </c:pt>
                <c:pt idx="19">
                  <c:v>6.1</c:v>
                </c:pt>
                <c:pt idx="20">
                  <c:v>10.1</c:v>
                </c:pt>
                <c:pt idx="21">
                  <c:v>6.3</c:v>
                </c:pt>
                <c:pt idx="22">
                  <c:v>11.2</c:v>
                </c:pt>
                <c:pt idx="23">
                  <c:v>5.8</c:v>
                </c:pt>
                <c:pt idx="24">
                  <c:v>8</c:v>
                </c:pt>
                <c:pt idx="25">
                  <c:v>8.1999999999999993</c:v>
                </c:pt>
                <c:pt idx="26">
                  <c:v>7.6</c:v>
                </c:pt>
                <c:pt idx="27">
                  <c:v>9</c:v>
                </c:pt>
                <c:pt idx="28">
                  <c:v>5.9</c:v>
                </c:pt>
                <c:pt idx="29">
                  <c:v>6.5</c:v>
                </c:pt>
                <c:pt idx="30">
                  <c:v>7.2</c:v>
                </c:pt>
                <c:pt idx="31">
                  <c:v>11.4</c:v>
                </c:pt>
                <c:pt idx="32">
                  <c:v>6.2</c:v>
                </c:pt>
                <c:pt idx="33">
                  <c:v>5.9</c:v>
                </c:pt>
                <c:pt idx="34">
                  <c:v>6.8</c:v>
                </c:pt>
                <c:pt idx="35">
                  <c:v>6.5</c:v>
                </c:pt>
                <c:pt idx="36">
                  <c:v>8.6</c:v>
                </c:pt>
                <c:pt idx="37">
                  <c:v>8.5</c:v>
                </c:pt>
                <c:pt idx="38">
                  <c:v>10.6</c:v>
                </c:pt>
                <c:pt idx="40">
                  <c:v>9.9</c:v>
                </c:pt>
                <c:pt idx="41">
                  <c:v>6.2</c:v>
                </c:pt>
                <c:pt idx="42">
                  <c:v>7.2</c:v>
                </c:pt>
                <c:pt idx="43">
                  <c:v>7.6</c:v>
                </c:pt>
                <c:pt idx="44">
                  <c:v>7</c:v>
                </c:pt>
                <c:pt idx="45">
                  <c:v>9.8000000000000007</c:v>
                </c:pt>
                <c:pt idx="46">
                  <c:v>9.4</c:v>
                </c:pt>
                <c:pt idx="47">
                  <c:v>7.2</c:v>
                </c:pt>
                <c:pt idx="48">
                  <c:v>7</c:v>
                </c:pt>
                <c:pt idx="49">
                  <c:v>6.9</c:v>
                </c:pt>
                <c:pt idx="50">
                  <c:v>14.9</c:v>
                </c:pt>
                <c:pt idx="51">
                  <c:v>6.7</c:v>
                </c:pt>
                <c:pt idx="52">
                  <c:v>9.6</c:v>
                </c:pt>
                <c:pt idx="53">
                  <c:v>8.1</c:v>
                </c:pt>
                <c:pt idx="54">
                  <c:v>9.1</c:v>
                </c:pt>
                <c:pt idx="55">
                  <c:v>7.2</c:v>
                </c:pt>
                <c:pt idx="56">
                  <c:v>8.1999999999999993</c:v>
                </c:pt>
                <c:pt idx="57">
                  <c:v>12.9</c:v>
                </c:pt>
                <c:pt idx="58">
                  <c:v>9.1</c:v>
                </c:pt>
                <c:pt idx="59">
                  <c:v>7.1</c:v>
                </c:pt>
                <c:pt idx="60">
                  <c:v>8.8000000000000007</c:v>
                </c:pt>
                <c:pt idx="61">
                  <c:v>8</c:v>
                </c:pt>
                <c:pt idx="62">
                  <c:v>9.4</c:v>
                </c:pt>
                <c:pt idx="63">
                  <c:v>9.6999999999999993</c:v>
                </c:pt>
                <c:pt idx="64">
                  <c:v>7.5</c:v>
                </c:pt>
                <c:pt idx="65">
                  <c:v>6.9</c:v>
                </c:pt>
                <c:pt idx="66">
                  <c:v>10.199999999999999</c:v>
                </c:pt>
                <c:pt idx="67">
                  <c:v>8</c:v>
                </c:pt>
                <c:pt idx="68">
                  <c:v>8.5</c:v>
                </c:pt>
                <c:pt idx="69">
                  <c:v>5.0999999999999996</c:v>
                </c:pt>
                <c:pt idx="70">
                  <c:v>7.6</c:v>
                </c:pt>
                <c:pt idx="72">
                  <c:v>7.1</c:v>
                </c:pt>
                <c:pt idx="73">
                  <c:v>8.9</c:v>
                </c:pt>
                <c:pt idx="75">
                  <c:v>7.5</c:v>
                </c:pt>
                <c:pt idx="77">
                  <c:v>8.1</c:v>
                </c:pt>
                <c:pt idx="78">
                  <c:v>8.4</c:v>
                </c:pt>
                <c:pt idx="79">
                  <c:v>6.5</c:v>
                </c:pt>
                <c:pt idx="80">
                  <c:v>6.4</c:v>
                </c:pt>
                <c:pt idx="81">
                  <c:v>8.1999999999999993</c:v>
                </c:pt>
                <c:pt idx="82">
                  <c:v>6.9</c:v>
                </c:pt>
                <c:pt idx="83">
                  <c:v>10</c:v>
                </c:pt>
                <c:pt idx="84">
                  <c:v>9.6</c:v>
                </c:pt>
                <c:pt idx="85">
                  <c:v>11.2</c:v>
                </c:pt>
                <c:pt idx="87">
                  <c:v>6.9</c:v>
                </c:pt>
                <c:pt idx="88">
                  <c:v>6.2</c:v>
                </c:pt>
                <c:pt idx="89">
                  <c:v>7.2</c:v>
                </c:pt>
                <c:pt idx="90">
                  <c:v>8.5</c:v>
                </c:pt>
                <c:pt idx="91">
                  <c:v>11.5</c:v>
                </c:pt>
                <c:pt idx="92">
                  <c:v>9.3000000000000007</c:v>
                </c:pt>
                <c:pt idx="93">
                  <c:v>9.8000000000000007</c:v>
                </c:pt>
                <c:pt idx="94">
                  <c:v>6.2</c:v>
                </c:pt>
                <c:pt idx="96">
                  <c:v>8.4</c:v>
                </c:pt>
                <c:pt idx="97">
                  <c:v>13.5</c:v>
                </c:pt>
                <c:pt idx="98">
                  <c:v>9.4</c:v>
                </c:pt>
                <c:pt idx="99">
                  <c:v>5.9</c:v>
                </c:pt>
                <c:pt idx="100">
                  <c:v>6.1</c:v>
                </c:pt>
                <c:pt idx="101">
                  <c:v>7.7</c:v>
                </c:pt>
                <c:pt idx="102">
                  <c:v>6.9</c:v>
                </c:pt>
                <c:pt idx="103">
                  <c:v>9</c:v>
                </c:pt>
                <c:pt idx="104">
                  <c:v>7.6</c:v>
                </c:pt>
                <c:pt idx="105">
                  <c:v>7.8</c:v>
                </c:pt>
                <c:pt idx="107">
                  <c:v>6.5</c:v>
                </c:pt>
                <c:pt idx="108">
                  <c:v>12.1</c:v>
                </c:pt>
                <c:pt idx="109">
                  <c:v>9.5</c:v>
                </c:pt>
                <c:pt idx="112">
                  <c:v>9</c:v>
                </c:pt>
                <c:pt idx="113">
                  <c:v>10</c:v>
                </c:pt>
                <c:pt idx="114">
                  <c:v>7.6</c:v>
                </c:pt>
                <c:pt idx="115">
                  <c:v>6.7</c:v>
                </c:pt>
                <c:pt idx="116">
                  <c:v>8.8000000000000007</c:v>
                </c:pt>
                <c:pt idx="117">
                  <c:v>6.9</c:v>
                </c:pt>
                <c:pt idx="118">
                  <c:v>5.9</c:v>
                </c:pt>
                <c:pt idx="119">
                  <c:v>6.6</c:v>
                </c:pt>
                <c:pt idx="121">
                  <c:v>7.2</c:v>
                </c:pt>
                <c:pt idx="122">
                  <c:v>9.5</c:v>
                </c:pt>
              </c:numCache>
            </c:numRef>
          </c:xVal>
          <c:yVal>
            <c:numRef>
              <c:f>Sheet1!$W$2:$W$129</c:f>
              <c:numCache>
                <c:formatCode>General</c:formatCode>
                <c:ptCount val="128"/>
                <c:pt idx="6" formatCode="#.00">
                  <c:v>81.86</c:v>
                </c:pt>
                <c:pt idx="9" formatCode="#.00">
                  <c:v>83.34</c:v>
                </c:pt>
                <c:pt idx="10" formatCode="#.00">
                  <c:v>82.28</c:v>
                </c:pt>
                <c:pt idx="11" formatCode="#.00">
                  <c:v>81.010000000000005</c:v>
                </c:pt>
                <c:pt idx="13" formatCode="#.00">
                  <c:v>82.25</c:v>
                </c:pt>
                <c:pt idx="14" formatCode="#.00">
                  <c:v>83.75</c:v>
                </c:pt>
                <c:pt idx="16" formatCode="#.00">
                  <c:v>81.56</c:v>
                </c:pt>
                <c:pt idx="28" formatCode="#.00">
                  <c:v>82.72</c:v>
                </c:pt>
                <c:pt idx="29" formatCode="#.00">
                  <c:v>79.7</c:v>
                </c:pt>
                <c:pt idx="30" formatCode="#.00">
                  <c:v>80.13</c:v>
                </c:pt>
                <c:pt idx="31" formatCode="#.00">
                  <c:v>83.51</c:v>
                </c:pt>
                <c:pt idx="32" formatCode="#.00">
                  <c:v>81.23</c:v>
                </c:pt>
                <c:pt idx="35" formatCode="#.00">
                  <c:v>81.34</c:v>
                </c:pt>
                <c:pt idx="36" formatCode="#.00">
                  <c:v>78.83</c:v>
                </c:pt>
                <c:pt idx="37" formatCode="#.00">
                  <c:v>81.010000000000005</c:v>
                </c:pt>
                <c:pt idx="38" formatCode="#.00">
                  <c:v>80.83</c:v>
                </c:pt>
                <c:pt idx="39" formatCode="#.00">
                  <c:v>80.64</c:v>
                </c:pt>
                <c:pt idx="40" formatCode="#.00">
                  <c:v>80.599999999999994</c:v>
                </c:pt>
                <c:pt idx="41" formatCode="#.00">
                  <c:v>81.42</c:v>
                </c:pt>
                <c:pt idx="42" formatCode="#.00">
                  <c:v>81.2</c:v>
                </c:pt>
                <c:pt idx="43" formatCode="#.00">
                  <c:v>80.64</c:v>
                </c:pt>
                <c:pt idx="44" formatCode="#.00">
                  <c:v>80.48</c:v>
                </c:pt>
                <c:pt idx="45" formatCode="#.00">
                  <c:v>82.06</c:v>
                </c:pt>
                <c:pt idx="46" formatCode="#.00">
                  <c:v>81.55</c:v>
                </c:pt>
                <c:pt idx="47" formatCode="#.00">
                  <c:v>79.77</c:v>
                </c:pt>
                <c:pt idx="48" formatCode="#.00">
                  <c:v>81.489999999999995</c:v>
                </c:pt>
                <c:pt idx="50" formatCode="#.00">
                  <c:v>83.37</c:v>
                </c:pt>
                <c:pt idx="51" formatCode="#.00">
                  <c:v>82.93</c:v>
                </c:pt>
                <c:pt idx="52" formatCode="#.00">
                  <c:v>80.680000000000007</c:v>
                </c:pt>
                <c:pt idx="53" formatCode="#.00">
                  <c:v>82.669999999999973</c:v>
                </c:pt>
                <c:pt idx="54" formatCode="#.00">
                  <c:v>81.790000000000006</c:v>
                </c:pt>
                <c:pt idx="55" formatCode="#.00">
                  <c:v>81.37</c:v>
                </c:pt>
                <c:pt idx="56" formatCode="#.00">
                  <c:v>80.5</c:v>
                </c:pt>
                <c:pt idx="57" formatCode="#.00">
                  <c:v>81.349999999999994</c:v>
                </c:pt>
                <c:pt idx="58" formatCode="#.00">
                  <c:v>81.91</c:v>
                </c:pt>
                <c:pt idx="59" formatCode="#.00">
                  <c:v>81.38</c:v>
                </c:pt>
                <c:pt idx="60" formatCode="#.00">
                  <c:v>81.650000000000006</c:v>
                </c:pt>
                <c:pt idx="61" formatCode="#.00">
                  <c:v>82.86</c:v>
                </c:pt>
                <c:pt idx="63" formatCode="#.00">
                  <c:v>82.55</c:v>
                </c:pt>
                <c:pt idx="64" formatCode="#.00">
                  <c:v>83.25</c:v>
                </c:pt>
                <c:pt idx="65" formatCode="#.00">
                  <c:v>83.35</c:v>
                </c:pt>
                <c:pt idx="66" formatCode="#.00">
                  <c:v>82.78</c:v>
                </c:pt>
                <c:pt idx="67" formatCode="#.00">
                  <c:v>82.1</c:v>
                </c:pt>
                <c:pt idx="68" formatCode="#.00">
                  <c:v>80.790000000000006</c:v>
                </c:pt>
                <c:pt idx="69" formatCode="#.00">
                  <c:v>79.97</c:v>
                </c:pt>
                <c:pt idx="70" formatCode="#.00">
                  <c:v>80.27</c:v>
                </c:pt>
                <c:pt idx="71" formatCode="#.00">
                  <c:v>79.08</c:v>
                </c:pt>
                <c:pt idx="72" formatCode="#.00">
                  <c:v>80.72</c:v>
                </c:pt>
                <c:pt idx="73" formatCode="#.00">
                  <c:v>82.41</c:v>
                </c:pt>
                <c:pt idx="74" formatCode="#.00">
                  <c:v>80.739999999999995</c:v>
                </c:pt>
                <c:pt idx="75" formatCode="#.00">
                  <c:v>81.290000000000006</c:v>
                </c:pt>
                <c:pt idx="76" formatCode="#.00">
                  <c:v>77.75</c:v>
                </c:pt>
                <c:pt idx="77" formatCode="#.00">
                  <c:v>80.45</c:v>
                </c:pt>
                <c:pt idx="78" formatCode="#.00">
                  <c:v>79.95</c:v>
                </c:pt>
                <c:pt idx="79" formatCode="#.00">
                  <c:v>81.11</c:v>
                </c:pt>
                <c:pt idx="80" formatCode="#.00">
                  <c:v>80.63</c:v>
                </c:pt>
                <c:pt idx="81" formatCode="#.00">
                  <c:v>80.53</c:v>
                </c:pt>
                <c:pt idx="82" formatCode="#.00">
                  <c:v>80.7</c:v>
                </c:pt>
                <c:pt idx="83" formatCode="#.00">
                  <c:v>81.16</c:v>
                </c:pt>
                <c:pt idx="84" formatCode="#.00">
                  <c:v>81.709999999999994</c:v>
                </c:pt>
                <c:pt idx="85" formatCode="#.00">
                  <c:v>81.669999999999973</c:v>
                </c:pt>
                <c:pt idx="86" formatCode="#.00">
                  <c:v>81.13</c:v>
                </c:pt>
                <c:pt idx="87" formatCode="#.00">
                  <c:v>81.28</c:v>
                </c:pt>
                <c:pt idx="88" formatCode="#.00">
                  <c:v>80.08</c:v>
                </c:pt>
                <c:pt idx="89" formatCode="#.00">
                  <c:v>80.6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3840512"/>
        <c:axId val="73846784"/>
      </c:scatterChart>
      <c:valAx>
        <c:axId val="73840512"/>
        <c:scaling>
          <c:orientation val="minMax"/>
          <c:min val="4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Hemoglobin </a:t>
                </a:r>
                <a:r>
                  <a:rPr lang="en-US" dirty="0" smtClean="0"/>
                  <a:t>A1C (%)</a:t>
                </a:r>
                <a:endParaRPr lang="en-US" dirty="0"/>
              </a:p>
            </c:rich>
          </c:tx>
          <c:layout/>
          <c:overlay val="0"/>
        </c:title>
        <c:numFmt formatCode="#.00" sourceLinked="1"/>
        <c:majorTickMark val="out"/>
        <c:minorTickMark val="none"/>
        <c:tickLblPos val="nextTo"/>
        <c:crossAx val="73846784"/>
        <c:crosses val="autoZero"/>
        <c:crossBetween val="midCat"/>
      </c:valAx>
      <c:valAx>
        <c:axId val="73846784"/>
        <c:scaling>
          <c:orientation val="minMax"/>
        </c:scaling>
        <c:delete val="0"/>
        <c:axPos val="l"/>
        <c:majorGridlines/>
        <c:min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% methylatio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7384051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W$1</c:f>
              <c:strCache>
                <c:ptCount val="1"/>
                <c:pt idx="0">
                  <c:v>hFKint2Region4Pyro2CpG5</c:v>
                </c:pt>
              </c:strCache>
            </c:strRef>
          </c:tx>
          <c:spPr>
            <a:ln w="47625">
              <a:noFill/>
            </a:ln>
          </c:spPr>
          <c:trendline>
            <c:trendlineType val="linear"/>
            <c:dispRSqr val="1"/>
            <c:dispEq val="1"/>
            <c:trendlineLbl>
              <c:layout>
                <c:manualLayout>
                  <c:x val="0.17358595800524901"/>
                  <c:y val="0.61021799358413498"/>
                </c:manualLayout>
              </c:layout>
              <c:numFmt formatCode="General" sourceLinked="0"/>
            </c:trendlineLbl>
          </c:trendline>
          <c:xVal>
            <c:numRef>
              <c:f>Sheet1!$M$2:$M$129</c:f>
              <c:numCache>
                <c:formatCode>0</c:formatCode>
                <c:ptCount val="128"/>
                <c:pt idx="0">
                  <c:v>63</c:v>
                </c:pt>
                <c:pt idx="1">
                  <c:v>132</c:v>
                </c:pt>
                <c:pt idx="2">
                  <c:v>59</c:v>
                </c:pt>
                <c:pt idx="3">
                  <c:v>70</c:v>
                </c:pt>
                <c:pt idx="4">
                  <c:v>0</c:v>
                </c:pt>
                <c:pt idx="6">
                  <c:v>51</c:v>
                </c:pt>
                <c:pt idx="7">
                  <c:v>124</c:v>
                </c:pt>
                <c:pt idx="8">
                  <c:v>80</c:v>
                </c:pt>
                <c:pt idx="9">
                  <c:v>222</c:v>
                </c:pt>
                <c:pt idx="10">
                  <c:v>105</c:v>
                </c:pt>
                <c:pt idx="11">
                  <c:v>71</c:v>
                </c:pt>
                <c:pt idx="12">
                  <c:v>108</c:v>
                </c:pt>
                <c:pt idx="14">
                  <c:v>161</c:v>
                </c:pt>
                <c:pt idx="15">
                  <c:v>59</c:v>
                </c:pt>
                <c:pt idx="16">
                  <c:v>68</c:v>
                </c:pt>
                <c:pt idx="18">
                  <c:v>100</c:v>
                </c:pt>
                <c:pt idx="19">
                  <c:v>100</c:v>
                </c:pt>
                <c:pt idx="23">
                  <c:v>77</c:v>
                </c:pt>
                <c:pt idx="24">
                  <c:v>61</c:v>
                </c:pt>
                <c:pt idx="25">
                  <c:v>104</c:v>
                </c:pt>
                <c:pt idx="26">
                  <c:v>76</c:v>
                </c:pt>
                <c:pt idx="27">
                  <c:v>108</c:v>
                </c:pt>
                <c:pt idx="28">
                  <c:v>22</c:v>
                </c:pt>
                <c:pt idx="29">
                  <c:v>78</c:v>
                </c:pt>
                <c:pt idx="30">
                  <c:v>117</c:v>
                </c:pt>
                <c:pt idx="31">
                  <c:v>41</c:v>
                </c:pt>
                <c:pt idx="33">
                  <c:v>105</c:v>
                </c:pt>
                <c:pt idx="34">
                  <c:v>97</c:v>
                </c:pt>
                <c:pt idx="35">
                  <c:v>50</c:v>
                </c:pt>
                <c:pt idx="36">
                  <c:v>81</c:v>
                </c:pt>
                <c:pt idx="37">
                  <c:v>77</c:v>
                </c:pt>
                <c:pt idx="38">
                  <c:v>115</c:v>
                </c:pt>
                <c:pt idx="39">
                  <c:v>89</c:v>
                </c:pt>
                <c:pt idx="40">
                  <c:v>111</c:v>
                </c:pt>
                <c:pt idx="41">
                  <c:v>49</c:v>
                </c:pt>
                <c:pt idx="42">
                  <c:v>53</c:v>
                </c:pt>
                <c:pt idx="43">
                  <c:v>45</c:v>
                </c:pt>
                <c:pt idx="45">
                  <c:v>74</c:v>
                </c:pt>
                <c:pt idx="46">
                  <c:v>162</c:v>
                </c:pt>
                <c:pt idx="47">
                  <c:v>56</c:v>
                </c:pt>
                <c:pt idx="48">
                  <c:v>70</c:v>
                </c:pt>
                <c:pt idx="49">
                  <c:v>43</c:v>
                </c:pt>
                <c:pt idx="50">
                  <c:v>85</c:v>
                </c:pt>
                <c:pt idx="52">
                  <c:v>126</c:v>
                </c:pt>
                <c:pt idx="53">
                  <c:v>45</c:v>
                </c:pt>
                <c:pt idx="54">
                  <c:v>85</c:v>
                </c:pt>
                <c:pt idx="55">
                  <c:v>93</c:v>
                </c:pt>
                <c:pt idx="56">
                  <c:v>61</c:v>
                </c:pt>
                <c:pt idx="57">
                  <c:v>121</c:v>
                </c:pt>
                <c:pt idx="58">
                  <c:v>106</c:v>
                </c:pt>
                <c:pt idx="59">
                  <c:v>121</c:v>
                </c:pt>
                <c:pt idx="60">
                  <c:v>133</c:v>
                </c:pt>
                <c:pt idx="61">
                  <c:v>49</c:v>
                </c:pt>
                <c:pt idx="62">
                  <c:v>57</c:v>
                </c:pt>
                <c:pt idx="63">
                  <c:v>175</c:v>
                </c:pt>
                <c:pt idx="65">
                  <c:v>86</c:v>
                </c:pt>
                <c:pt idx="66">
                  <c:v>96</c:v>
                </c:pt>
                <c:pt idx="67">
                  <c:v>46</c:v>
                </c:pt>
                <c:pt idx="69">
                  <c:v>74</c:v>
                </c:pt>
                <c:pt idx="70">
                  <c:v>78</c:v>
                </c:pt>
                <c:pt idx="72">
                  <c:v>76</c:v>
                </c:pt>
                <c:pt idx="73">
                  <c:v>125</c:v>
                </c:pt>
                <c:pt idx="74">
                  <c:v>75</c:v>
                </c:pt>
                <c:pt idx="77">
                  <c:v>83</c:v>
                </c:pt>
                <c:pt idx="79">
                  <c:v>80</c:v>
                </c:pt>
                <c:pt idx="80">
                  <c:v>104</c:v>
                </c:pt>
                <c:pt idx="81">
                  <c:v>67</c:v>
                </c:pt>
                <c:pt idx="82">
                  <c:v>105</c:v>
                </c:pt>
                <c:pt idx="83">
                  <c:v>94</c:v>
                </c:pt>
                <c:pt idx="84">
                  <c:v>159</c:v>
                </c:pt>
                <c:pt idx="85">
                  <c:v>82</c:v>
                </c:pt>
                <c:pt idx="87">
                  <c:v>150</c:v>
                </c:pt>
                <c:pt idx="88">
                  <c:v>85</c:v>
                </c:pt>
                <c:pt idx="89">
                  <c:v>61</c:v>
                </c:pt>
                <c:pt idx="90">
                  <c:v>128</c:v>
                </c:pt>
                <c:pt idx="91">
                  <c:v>78</c:v>
                </c:pt>
                <c:pt idx="92">
                  <c:v>81</c:v>
                </c:pt>
                <c:pt idx="93">
                  <c:v>86</c:v>
                </c:pt>
                <c:pt idx="94">
                  <c:v>56</c:v>
                </c:pt>
                <c:pt idx="95">
                  <c:v>66</c:v>
                </c:pt>
                <c:pt idx="97">
                  <c:v>137</c:v>
                </c:pt>
                <c:pt idx="98">
                  <c:v>100</c:v>
                </c:pt>
                <c:pt idx="99">
                  <c:v>63</c:v>
                </c:pt>
                <c:pt idx="100">
                  <c:v>122</c:v>
                </c:pt>
                <c:pt idx="101">
                  <c:v>173</c:v>
                </c:pt>
                <c:pt idx="102">
                  <c:v>59</c:v>
                </c:pt>
                <c:pt idx="103">
                  <c:v>98</c:v>
                </c:pt>
                <c:pt idx="104">
                  <c:v>171</c:v>
                </c:pt>
                <c:pt idx="105">
                  <c:v>100</c:v>
                </c:pt>
                <c:pt idx="106">
                  <c:v>47</c:v>
                </c:pt>
                <c:pt idx="108">
                  <c:v>138</c:v>
                </c:pt>
                <c:pt idx="109">
                  <c:v>195</c:v>
                </c:pt>
                <c:pt idx="112">
                  <c:v>64</c:v>
                </c:pt>
                <c:pt idx="113">
                  <c:v>58</c:v>
                </c:pt>
                <c:pt idx="114">
                  <c:v>62</c:v>
                </c:pt>
                <c:pt idx="115">
                  <c:v>130</c:v>
                </c:pt>
                <c:pt idx="116">
                  <c:v>105</c:v>
                </c:pt>
                <c:pt idx="118">
                  <c:v>158</c:v>
                </c:pt>
                <c:pt idx="119">
                  <c:v>112</c:v>
                </c:pt>
                <c:pt idx="122">
                  <c:v>37</c:v>
                </c:pt>
              </c:numCache>
            </c:numRef>
          </c:xVal>
          <c:yVal>
            <c:numRef>
              <c:f>Sheet1!$W$2:$W$129</c:f>
              <c:numCache>
                <c:formatCode>General</c:formatCode>
                <c:ptCount val="128"/>
                <c:pt idx="6" formatCode="#.00">
                  <c:v>81.86</c:v>
                </c:pt>
                <c:pt idx="9" formatCode="#.00">
                  <c:v>83.34</c:v>
                </c:pt>
                <c:pt idx="10" formatCode="#.00">
                  <c:v>82.28</c:v>
                </c:pt>
                <c:pt idx="11" formatCode="#.00">
                  <c:v>81.010000000000005</c:v>
                </c:pt>
                <c:pt idx="13" formatCode="#.00">
                  <c:v>82.25</c:v>
                </c:pt>
                <c:pt idx="14" formatCode="#.00">
                  <c:v>83.75</c:v>
                </c:pt>
                <c:pt idx="16" formatCode="#.00">
                  <c:v>81.56</c:v>
                </c:pt>
                <c:pt idx="28" formatCode="#.00">
                  <c:v>82.72</c:v>
                </c:pt>
                <c:pt idx="29" formatCode="#.00">
                  <c:v>79.7</c:v>
                </c:pt>
                <c:pt idx="30" formatCode="#.00">
                  <c:v>80.13</c:v>
                </c:pt>
                <c:pt idx="31" formatCode="#.00">
                  <c:v>83.51</c:v>
                </c:pt>
                <c:pt idx="32" formatCode="#.00">
                  <c:v>81.23</c:v>
                </c:pt>
                <c:pt idx="35" formatCode="#.00">
                  <c:v>81.34</c:v>
                </c:pt>
                <c:pt idx="36" formatCode="#.00">
                  <c:v>78.83</c:v>
                </c:pt>
                <c:pt idx="37" formatCode="#.00">
                  <c:v>81.010000000000005</c:v>
                </c:pt>
                <c:pt idx="38" formatCode="#.00">
                  <c:v>80.83</c:v>
                </c:pt>
                <c:pt idx="39" formatCode="#.00">
                  <c:v>80.64</c:v>
                </c:pt>
                <c:pt idx="40" formatCode="#.00">
                  <c:v>80.599999999999994</c:v>
                </c:pt>
                <c:pt idx="41" formatCode="#.00">
                  <c:v>81.42</c:v>
                </c:pt>
                <c:pt idx="42" formatCode="#.00">
                  <c:v>81.2</c:v>
                </c:pt>
                <c:pt idx="43" formatCode="#.00">
                  <c:v>80.64</c:v>
                </c:pt>
                <c:pt idx="44" formatCode="#.00">
                  <c:v>80.48</c:v>
                </c:pt>
                <c:pt idx="45" formatCode="#.00">
                  <c:v>82.06</c:v>
                </c:pt>
                <c:pt idx="46" formatCode="#.00">
                  <c:v>81.55</c:v>
                </c:pt>
                <c:pt idx="47" formatCode="#.00">
                  <c:v>79.77</c:v>
                </c:pt>
                <c:pt idx="48" formatCode="#.00">
                  <c:v>81.489999999999995</c:v>
                </c:pt>
                <c:pt idx="50" formatCode="#.00">
                  <c:v>83.37</c:v>
                </c:pt>
                <c:pt idx="51" formatCode="#.00">
                  <c:v>82.93</c:v>
                </c:pt>
                <c:pt idx="52" formatCode="#.00">
                  <c:v>80.680000000000007</c:v>
                </c:pt>
                <c:pt idx="53" formatCode="#.00">
                  <c:v>82.669999999999973</c:v>
                </c:pt>
                <c:pt idx="54" formatCode="#.00">
                  <c:v>81.790000000000006</c:v>
                </c:pt>
                <c:pt idx="55" formatCode="#.00">
                  <c:v>81.37</c:v>
                </c:pt>
                <c:pt idx="56" formatCode="#.00">
                  <c:v>80.5</c:v>
                </c:pt>
                <c:pt idx="57" formatCode="#.00">
                  <c:v>81.349999999999994</c:v>
                </c:pt>
                <c:pt idx="58" formatCode="#.00">
                  <c:v>81.91</c:v>
                </c:pt>
                <c:pt idx="59" formatCode="#.00">
                  <c:v>81.38</c:v>
                </c:pt>
                <c:pt idx="60" formatCode="#.00">
                  <c:v>81.650000000000006</c:v>
                </c:pt>
                <c:pt idx="61" formatCode="#.00">
                  <c:v>82.86</c:v>
                </c:pt>
                <c:pt idx="63" formatCode="#.00">
                  <c:v>82.55</c:v>
                </c:pt>
                <c:pt idx="64" formatCode="#.00">
                  <c:v>83.25</c:v>
                </c:pt>
                <c:pt idx="65" formatCode="#.00">
                  <c:v>83.35</c:v>
                </c:pt>
                <c:pt idx="66" formatCode="#.00">
                  <c:v>82.78</c:v>
                </c:pt>
                <c:pt idx="67" formatCode="#.00">
                  <c:v>82.1</c:v>
                </c:pt>
                <c:pt idx="68" formatCode="#.00">
                  <c:v>80.790000000000006</c:v>
                </c:pt>
                <c:pt idx="69" formatCode="#.00">
                  <c:v>79.97</c:v>
                </c:pt>
                <c:pt idx="70" formatCode="#.00">
                  <c:v>80.27</c:v>
                </c:pt>
                <c:pt idx="71" formatCode="#.00">
                  <c:v>79.08</c:v>
                </c:pt>
                <c:pt idx="72" formatCode="#.00">
                  <c:v>80.72</c:v>
                </c:pt>
                <c:pt idx="73" formatCode="#.00">
                  <c:v>82.41</c:v>
                </c:pt>
                <c:pt idx="74" formatCode="#.00">
                  <c:v>80.739999999999995</c:v>
                </c:pt>
                <c:pt idx="75" formatCode="#.00">
                  <c:v>81.290000000000006</c:v>
                </c:pt>
                <c:pt idx="76" formatCode="#.00">
                  <c:v>77.75</c:v>
                </c:pt>
                <c:pt idx="77" formatCode="#.00">
                  <c:v>80.45</c:v>
                </c:pt>
                <c:pt idx="78" formatCode="#.00">
                  <c:v>79.95</c:v>
                </c:pt>
                <c:pt idx="79" formatCode="#.00">
                  <c:v>81.11</c:v>
                </c:pt>
                <c:pt idx="80" formatCode="#.00">
                  <c:v>80.63</c:v>
                </c:pt>
                <c:pt idx="81" formatCode="#.00">
                  <c:v>80.53</c:v>
                </c:pt>
                <c:pt idx="82" formatCode="#.00">
                  <c:v>80.7</c:v>
                </c:pt>
                <c:pt idx="83" formatCode="#.00">
                  <c:v>81.16</c:v>
                </c:pt>
                <c:pt idx="84" formatCode="#.00">
                  <c:v>81.709999999999994</c:v>
                </c:pt>
                <c:pt idx="85" formatCode="#.00">
                  <c:v>81.669999999999973</c:v>
                </c:pt>
                <c:pt idx="86" formatCode="#.00">
                  <c:v>81.13</c:v>
                </c:pt>
                <c:pt idx="87" formatCode="#.00">
                  <c:v>81.28</c:v>
                </c:pt>
                <c:pt idx="88" formatCode="#.00">
                  <c:v>80.08</c:v>
                </c:pt>
                <c:pt idx="89" formatCode="#.00">
                  <c:v>80.6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4473856"/>
        <c:axId val="74475776"/>
      </c:scatterChart>
      <c:valAx>
        <c:axId val="7447385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LDL </a:t>
                </a:r>
                <a:r>
                  <a:rPr lang="en-US" dirty="0" smtClean="0"/>
                  <a:t>(</a:t>
                </a:r>
                <a:r>
                  <a:rPr lang="en-US" sz="1000" b="1" i="0" u="none" strike="noStrike" baseline="0" dirty="0" smtClean="0">
                    <a:effectLst/>
                  </a:rPr>
                  <a:t>mg/dL</a:t>
                </a:r>
                <a:r>
                  <a:rPr lang="en-US" dirty="0" smtClean="0"/>
                  <a:t>)</a:t>
                </a:r>
                <a:endParaRPr lang="en-US" dirty="0"/>
              </a:p>
            </c:rich>
          </c:tx>
          <c:layout/>
          <c:overlay val="0"/>
        </c:title>
        <c:numFmt formatCode="0" sourceLinked="1"/>
        <c:majorTickMark val="out"/>
        <c:minorTickMark val="none"/>
        <c:tickLblPos val="nextTo"/>
        <c:crossAx val="74475776"/>
        <c:crosses val="autoZero"/>
        <c:crossBetween val="midCat"/>
      </c:valAx>
      <c:valAx>
        <c:axId val="74475776"/>
        <c:scaling>
          <c:orientation val="minMax"/>
        </c:scaling>
        <c:delete val="0"/>
        <c:axPos val="l"/>
        <c:majorGridlines/>
        <c:min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% methylatio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74473856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V$1</c:f>
              <c:strCache>
                <c:ptCount val="1"/>
                <c:pt idx="0">
                  <c:v>hFKint2Region4Pyro1CpG3</c:v>
                </c:pt>
              </c:strCache>
            </c:strRef>
          </c:tx>
          <c:spPr>
            <a:ln w="47625">
              <a:noFill/>
            </a:ln>
          </c:spPr>
          <c:trendline>
            <c:trendlineType val="linear"/>
            <c:dispRSqr val="1"/>
            <c:dispEq val="1"/>
            <c:trendlineLbl>
              <c:layout>
                <c:manualLayout>
                  <c:x val="0.237141732283465"/>
                  <c:y val="0.60772054534849795"/>
                </c:manualLayout>
              </c:layout>
              <c:numFmt formatCode="General" sourceLinked="0"/>
            </c:trendlineLbl>
          </c:trendline>
          <c:xVal>
            <c:numRef>
              <c:f>Sheet1!$G$2:$G$129</c:f>
              <c:numCache>
                <c:formatCode>#.00</c:formatCode>
                <c:ptCount val="128"/>
                <c:pt idx="0">
                  <c:v>36.33846152473447</c:v>
                </c:pt>
                <c:pt idx="1">
                  <c:v>48.235395818614862</c:v>
                </c:pt>
                <c:pt idx="2">
                  <c:v>27.18159196138819</c:v>
                </c:pt>
                <c:pt idx="3">
                  <c:v>30.33053789868714</c:v>
                </c:pt>
                <c:pt idx="4">
                  <c:v>28.897429953950819</c:v>
                </c:pt>
                <c:pt idx="5">
                  <c:v>31.59817984795728</c:v>
                </c:pt>
                <c:pt idx="6">
                  <c:v>19.410985018630509</c:v>
                </c:pt>
                <c:pt idx="7">
                  <c:v>36.098413597017547</c:v>
                </c:pt>
                <c:pt idx="8">
                  <c:v>37.040111343026702</c:v>
                </c:pt>
                <c:pt idx="9">
                  <c:v>28.116762043991709</c:v>
                </c:pt>
                <c:pt idx="10">
                  <c:v>33.744169231994668</c:v>
                </c:pt>
                <c:pt idx="11">
                  <c:v>51.122723241757342</c:v>
                </c:pt>
                <c:pt idx="12">
                  <c:v>30.085716737090021</c:v>
                </c:pt>
                <c:pt idx="13">
                  <c:v>28.181874545567268</c:v>
                </c:pt>
                <c:pt idx="14">
                  <c:v>36.278199159706332</c:v>
                </c:pt>
                <c:pt idx="15">
                  <c:v>43.805072947389299</c:v>
                </c:pt>
                <c:pt idx="16">
                  <c:v>30.138949166787221</c:v>
                </c:pt>
                <c:pt idx="18">
                  <c:v>38.013881070375767</c:v>
                </c:pt>
                <c:pt idx="19">
                  <c:v>49.525970006382401</c:v>
                </c:pt>
                <c:pt idx="20">
                  <c:v>35.196869701697892</c:v>
                </c:pt>
                <c:pt idx="21">
                  <c:v>31.835361240285788</c:v>
                </c:pt>
                <c:pt idx="22">
                  <c:v>37.934928151191883</c:v>
                </c:pt>
                <c:pt idx="23">
                  <c:v>23.464579801131769</c:v>
                </c:pt>
                <c:pt idx="24">
                  <c:v>36.058934897621299</c:v>
                </c:pt>
                <c:pt idx="25">
                  <c:v>26.906151829512801</c:v>
                </c:pt>
                <c:pt idx="26">
                  <c:v>32.113798682296199</c:v>
                </c:pt>
                <c:pt idx="27">
                  <c:v>27.589315840809011</c:v>
                </c:pt>
                <c:pt idx="28">
                  <c:v>39.467577825234237</c:v>
                </c:pt>
                <c:pt idx="29">
                  <c:v>32.720346766346758</c:v>
                </c:pt>
                <c:pt idx="30">
                  <c:v>27.533372770664322</c:v>
                </c:pt>
                <c:pt idx="31">
                  <c:v>39.807415735967197</c:v>
                </c:pt>
                <c:pt idx="32">
                  <c:v>46.258127410653337</c:v>
                </c:pt>
                <c:pt idx="33">
                  <c:v>30.39390400513755</c:v>
                </c:pt>
                <c:pt idx="34">
                  <c:v>23.857580563172501</c:v>
                </c:pt>
                <c:pt idx="35">
                  <c:v>52.7350737765126</c:v>
                </c:pt>
                <c:pt idx="36">
                  <c:v>33.713668279609273</c:v>
                </c:pt>
                <c:pt idx="37">
                  <c:v>33.822721880714539</c:v>
                </c:pt>
                <c:pt idx="38">
                  <c:v>33.15704936777599</c:v>
                </c:pt>
                <c:pt idx="39">
                  <c:v>29.11203971701331</c:v>
                </c:pt>
                <c:pt idx="40">
                  <c:v>53.968705459654728</c:v>
                </c:pt>
                <c:pt idx="41">
                  <c:v>21.940905788071412</c:v>
                </c:pt>
                <c:pt idx="42">
                  <c:v>34.520621790962998</c:v>
                </c:pt>
                <c:pt idx="43">
                  <c:v>36.840249633578438</c:v>
                </c:pt>
                <c:pt idx="44">
                  <c:v>54.909591630035678</c:v>
                </c:pt>
                <c:pt idx="45">
                  <c:v>32.550875727348817</c:v>
                </c:pt>
                <c:pt idx="46">
                  <c:v>42.052843100593947</c:v>
                </c:pt>
                <c:pt idx="47">
                  <c:v>29.684907854664189</c:v>
                </c:pt>
                <c:pt idx="48">
                  <c:v>32.774497029039487</c:v>
                </c:pt>
                <c:pt idx="49">
                  <c:v>26.014038042062101</c:v>
                </c:pt>
                <c:pt idx="50">
                  <c:v>30.099807674362818</c:v>
                </c:pt>
                <c:pt idx="51">
                  <c:v>59.198612211102862</c:v>
                </c:pt>
                <c:pt idx="52">
                  <c:v>49.030710306318568</c:v>
                </c:pt>
                <c:pt idx="53">
                  <c:v>28.777266261318701</c:v>
                </c:pt>
                <c:pt idx="54">
                  <c:v>35.937135288965301</c:v>
                </c:pt>
                <c:pt idx="55">
                  <c:v>48.282571950548608</c:v>
                </c:pt>
                <c:pt idx="56">
                  <c:v>44.20617682453048</c:v>
                </c:pt>
                <c:pt idx="57">
                  <c:v>26.340658741923541</c:v>
                </c:pt>
                <c:pt idx="58">
                  <c:v>41.900802789780037</c:v>
                </c:pt>
                <c:pt idx="59">
                  <c:v>22.84585068036349</c:v>
                </c:pt>
                <c:pt idx="60">
                  <c:v>30.319124290645568</c:v>
                </c:pt>
                <c:pt idx="61">
                  <c:v>35.61949802099371</c:v>
                </c:pt>
                <c:pt idx="62">
                  <c:v>27.31916410029481</c:v>
                </c:pt>
                <c:pt idx="63">
                  <c:v>27.466184258600311</c:v>
                </c:pt>
                <c:pt idx="64">
                  <c:v>35.777770419177202</c:v>
                </c:pt>
                <c:pt idx="65">
                  <c:v>27.959418139660439</c:v>
                </c:pt>
                <c:pt idx="66">
                  <c:v>36.871829495622791</c:v>
                </c:pt>
                <c:pt idx="67">
                  <c:v>24.65914022737136</c:v>
                </c:pt>
                <c:pt idx="68">
                  <c:v>34.929693583370202</c:v>
                </c:pt>
                <c:pt idx="69">
                  <c:v>32.017277590230059</c:v>
                </c:pt>
                <c:pt idx="70">
                  <c:v>43.490547138221103</c:v>
                </c:pt>
                <c:pt idx="71">
                  <c:v>45.844985268212028</c:v>
                </c:pt>
                <c:pt idx="72">
                  <c:v>24.01864307860847</c:v>
                </c:pt>
                <c:pt idx="73">
                  <c:v>36.35295059724038</c:v>
                </c:pt>
                <c:pt idx="74">
                  <c:v>42.155509530960408</c:v>
                </c:pt>
                <c:pt idx="75">
                  <c:v>29.741953811455769</c:v>
                </c:pt>
                <c:pt idx="76">
                  <c:v>29.27524846618272</c:v>
                </c:pt>
                <c:pt idx="77">
                  <c:v>34.23446851931007</c:v>
                </c:pt>
                <c:pt idx="78">
                  <c:v>40.920651170962543</c:v>
                </c:pt>
                <c:pt idx="79">
                  <c:v>30.74849786474352</c:v>
                </c:pt>
                <c:pt idx="80">
                  <c:v>36.230141748204019</c:v>
                </c:pt>
                <c:pt idx="81">
                  <c:v>23.802258906729111</c:v>
                </c:pt>
                <c:pt idx="82">
                  <c:v>34.145962720077932</c:v>
                </c:pt>
                <c:pt idx="83">
                  <c:v>22.57914191093429</c:v>
                </c:pt>
                <c:pt idx="84">
                  <c:v>30.138949166787221</c:v>
                </c:pt>
                <c:pt idx="85">
                  <c:v>29.69640651454943</c:v>
                </c:pt>
                <c:pt idx="86">
                  <c:v>25.45306879771881</c:v>
                </c:pt>
                <c:pt idx="87">
                  <c:v>45.64440221152185</c:v>
                </c:pt>
                <c:pt idx="88">
                  <c:v>33.673195688637371</c:v>
                </c:pt>
                <c:pt idx="89">
                  <c:v>36.219579024662274</c:v>
                </c:pt>
                <c:pt idx="92">
                  <c:v>46.419869114886239</c:v>
                </c:pt>
                <c:pt idx="93">
                  <c:v>55.096052312268213</c:v>
                </c:pt>
                <c:pt idx="94">
                  <c:v>27.177363166645399</c:v>
                </c:pt>
                <c:pt idx="96">
                  <c:v>24.179714846788489</c:v>
                </c:pt>
                <c:pt idx="97">
                  <c:v>55.964672150464267</c:v>
                </c:pt>
                <c:pt idx="98">
                  <c:v>29.757472512104108</c:v>
                </c:pt>
                <c:pt idx="99">
                  <c:v>33.451823328376037</c:v>
                </c:pt>
                <c:pt idx="100">
                  <c:v>62.013532331562928</c:v>
                </c:pt>
                <c:pt idx="101">
                  <c:v>30.178090659211609</c:v>
                </c:pt>
                <c:pt idx="102">
                  <c:v>34.07706258826223</c:v>
                </c:pt>
                <c:pt idx="103">
                  <c:v>40.28191121602346</c:v>
                </c:pt>
                <c:pt idx="104">
                  <c:v>39.383431238094538</c:v>
                </c:pt>
                <c:pt idx="105">
                  <c:v>32.510082550843592</c:v>
                </c:pt>
                <c:pt idx="106">
                  <c:v>32.332362557144123</c:v>
                </c:pt>
                <c:pt idx="107">
                  <c:v>30.53036409103121</c:v>
                </c:pt>
                <c:pt idx="108">
                  <c:v>27.965140661894981</c:v>
                </c:pt>
                <c:pt idx="109">
                  <c:v>29.430656340005861</c:v>
                </c:pt>
                <c:pt idx="110">
                  <c:v>48.743140157894388</c:v>
                </c:pt>
                <c:pt idx="111">
                  <c:v>35.949778930807852</c:v>
                </c:pt>
                <c:pt idx="112">
                  <c:v>35.217876010988398</c:v>
                </c:pt>
                <c:pt idx="113">
                  <c:v>30.77000588138467</c:v>
                </c:pt>
                <c:pt idx="114">
                  <c:v>35.421433227038747</c:v>
                </c:pt>
                <c:pt idx="115">
                  <c:v>27.3369153440247</c:v>
                </c:pt>
                <c:pt idx="116">
                  <c:v>31.982200853565981</c:v>
                </c:pt>
                <c:pt idx="117">
                  <c:v>35.423050644081073</c:v>
                </c:pt>
                <c:pt idx="118">
                  <c:v>30.747928982467769</c:v>
                </c:pt>
                <c:pt idx="119">
                  <c:v>31.744063488126979</c:v>
                </c:pt>
                <c:pt idx="121">
                  <c:v>26.488949504602679</c:v>
                </c:pt>
                <c:pt idx="122">
                  <c:v>25.89668801525173</c:v>
                </c:pt>
              </c:numCache>
            </c:numRef>
          </c:xVal>
          <c:yVal>
            <c:numRef>
              <c:f>Sheet1!$V$2:$V$129</c:f>
              <c:numCache>
                <c:formatCode>General</c:formatCode>
                <c:ptCount val="128"/>
                <c:pt idx="6" formatCode="#.00">
                  <c:v>66.669999999999973</c:v>
                </c:pt>
                <c:pt idx="9" formatCode="#.00">
                  <c:v>63.79</c:v>
                </c:pt>
                <c:pt idx="10" formatCode="#.00">
                  <c:v>68.87</c:v>
                </c:pt>
                <c:pt idx="11" formatCode="#.00">
                  <c:v>69.89</c:v>
                </c:pt>
                <c:pt idx="13" formatCode="#.00">
                  <c:v>67.290000000000006</c:v>
                </c:pt>
                <c:pt idx="14" formatCode="#.00">
                  <c:v>68.790000000000006</c:v>
                </c:pt>
                <c:pt idx="16" formatCode="#.00">
                  <c:v>68.2</c:v>
                </c:pt>
                <c:pt idx="29" formatCode="#.00">
                  <c:v>65.8</c:v>
                </c:pt>
                <c:pt idx="30" formatCode="#.00">
                  <c:v>66.959999999999994</c:v>
                </c:pt>
                <c:pt idx="31" formatCode="#.00">
                  <c:v>64.260000000000005</c:v>
                </c:pt>
                <c:pt idx="32" formatCode="#.00">
                  <c:v>67.430000000000007</c:v>
                </c:pt>
                <c:pt idx="35" formatCode="#.00">
                  <c:v>70.34</c:v>
                </c:pt>
                <c:pt idx="36" formatCode="#.00">
                  <c:v>64.02</c:v>
                </c:pt>
                <c:pt idx="37" formatCode="#.00">
                  <c:v>66.569999999999993</c:v>
                </c:pt>
                <c:pt idx="38" formatCode="#.00">
                  <c:v>65.02</c:v>
                </c:pt>
                <c:pt idx="39" formatCode="#.00">
                  <c:v>64.849999999999994</c:v>
                </c:pt>
                <c:pt idx="40" formatCode="#.00">
                  <c:v>69.760000000000005</c:v>
                </c:pt>
                <c:pt idx="41" formatCode="#.00">
                  <c:v>64.47</c:v>
                </c:pt>
                <c:pt idx="42" formatCode="#.00">
                  <c:v>68.2</c:v>
                </c:pt>
                <c:pt idx="43" formatCode="#.00">
                  <c:v>66.169999999999973</c:v>
                </c:pt>
                <c:pt idx="44" formatCode="#.00">
                  <c:v>66.94</c:v>
                </c:pt>
                <c:pt idx="45" formatCode="#.00">
                  <c:v>66.11</c:v>
                </c:pt>
                <c:pt idx="46" formatCode="#.00">
                  <c:v>65.459999999999994</c:v>
                </c:pt>
                <c:pt idx="47" formatCode="#.00">
                  <c:v>65.150000000000006</c:v>
                </c:pt>
                <c:pt idx="48" formatCode="#.00">
                  <c:v>64.41</c:v>
                </c:pt>
                <c:pt idx="50" formatCode="#.00">
                  <c:v>69.099999999999994</c:v>
                </c:pt>
                <c:pt idx="51" formatCode="#.00">
                  <c:v>67.41</c:v>
                </c:pt>
                <c:pt idx="52" formatCode="#.00">
                  <c:v>63.24</c:v>
                </c:pt>
                <c:pt idx="53" formatCode="#.00">
                  <c:v>67.44</c:v>
                </c:pt>
                <c:pt idx="54" formatCode="#.00">
                  <c:v>66.05</c:v>
                </c:pt>
                <c:pt idx="55" formatCode="#.00">
                  <c:v>65.06</c:v>
                </c:pt>
                <c:pt idx="56" formatCode="#.00">
                  <c:v>66.08</c:v>
                </c:pt>
                <c:pt idx="57" formatCode="#.00">
                  <c:v>65.62</c:v>
                </c:pt>
                <c:pt idx="58" formatCode="#.00">
                  <c:v>65.77</c:v>
                </c:pt>
                <c:pt idx="59" formatCode="#.00">
                  <c:v>66.169999999999973</c:v>
                </c:pt>
                <c:pt idx="60" formatCode="#.00">
                  <c:v>67.2</c:v>
                </c:pt>
                <c:pt idx="61" formatCode="#.00">
                  <c:v>67.62</c:v>
                </c:pt>
                <c:pt idx="63" formatCode="#.00">
                  <c:v>65.489999999999995</c:v>
                </c:pt>
                <c:pt idx="64" formatCode="#.00">
                  <c:v>63.59</c:v>
                </c:pt>
                <c:pt idx="65" formatCode="#.00">
                  <c:v>67.540000000000006</c:v>
                </c:pt>
                <c:pt idx="66" formatCode="#.00">
                  <c:v>67.38</c:v>
                </c:pt>
                <c:pt idx="67" formatCode="#.00">
                  <c:v>66.88</c:v>
                </c:pt>
                <c:pt idx="68" formatCode="#.00">
                  <c:v>68.38</c:v>
                </c:pt>
                <c:pt idx="69" formatCode="#.00">
                  <c:v>66.94</c:v>
                </c:pt>
                <c:pt idx="70" formatCode="#.00">
                  <c:v>67.42</c:v>
                </c:pt>
                <c:pt idx="71" formatCode="#.00">
                  <c:v>68.09</c:v>
                </c:pt>
                <c:pt idx="72" formatCode="#.00">
                  <c:v>65.959999999999994</c:v>
                </c:pt>
                <c:pt idx="73" formatCode="#.00">
                  <c:v>64.959999999999994</c:v>
                </c:pt>
                <c:pt idx="74" formatCode="#.00">
                  <c:v>65.81</c:v>
                </c:pt>
                <c:pt idx="75" formatCode="#.00">
                  <c:v>68.62</c:v>
                </c:pt>
                <c:pt idx="76" formatCode="#.00">
                  <c:v>68.09</c:v>
                </c:pt>
                <c:pt idx="77" formatCode="#.00">
                  <c:v>65.599999999999994</c:v>
                </c:pt>
                <c:pt idx="78" formatCode="#.00">
                  <c:v>71.56</c:v>
                </c:pt>
                <c:pt idx="79" formatCode="#.00">
                  <c:v>65.91</c:v>
                </c:pt>
                <c:pt idx="80" formatCode="#.00">
                  <c:v>66.39</c:v>
                </c:pt>
                <c:pt idx="81" formatCode="#.00">
                  <c:v>64.83</c:v>
                </c:pt>
                <c:pt idx="82" formatCode="#.00">
                  <c:v>64.42</c:v>
                </c:pt>
                <c:pt idx="83" formatCode="#.00">
                  <c:v>66.150000000000006</c:v>
                </c:pt>
                <c:pt idx="84" formatCode="#.00">
                  <c:v>64.48</c:v>
                </c:pt>
                <c:pt idx="85" formatCode="#.00">
                  <c:v>65.27</c:v>
                </c:pt>
                <c:pt idx="86" formatCode="#.00">
                  <c:v>65.11</c:v>
                </c:pt>
                <c:pt idx="87" formatCode="#.00">
                  <c:v>70.3</c:v>
                </c:pt>
                <c:pt idx="88" formatCode="#.00">
                  <c:v>65.72</c:v>
                </c:pt>
                <c:pt idx="89" formatCode="#.00">
                  <c:v>65.8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4488448"/>
        <c:axId val="74511104"/>
      </c:scatterChart>
      <c:valAx>
        <c:axId val="74488448"/>
        <c:scaling>
          <c:orientation val="minMax"/>
          <c:min val="15"/>
        </c:scaling>
        <c:delete val="0"/>
        <c:axPos val="b"/>
        <c:title>
          <c:tx>
            <c:rich>
              <a:bodyPr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1" i="0" u="none" strike="noStrike" kern="1200" baseline="0">
                    <a:solidFill>
                      <a:prstClr val="black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 smtClean="0"/>
                  <a:t>BM</a:t>
                </a:r>
                <a:r>
                  <a:rPr lang="en-US" sz="1000" dirty="0" smtClean="0"/>
                  <a:t>I</a:t>
                </a:r>
              </a:p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1" i="0" u="none" strike="noStrike" kern="1200" baseline="0">
                    <a:solidFill>
                      <a:prstClr val="black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1" i="0" baseline="0" dirty="0" smtClean="0">
                    <a:effectLst/>
                  </a:rPr>
                  <a:t>(mg/m</a:t>
                </a:r>
                <a:r>
                  <a:rPr lang="en-US" sz="1000" b="1" i="0" baseline="30000" dirty="0" smtClean="0">
                    <a:effectLst/>
                  </a:rPr>
                  <a:t>2</a:t>
                </a:r>
                <a:r>
                  <a:rPr lang="en-US" sz="1000" b="1" i="0" baseline="0" dirty="0" smtClean="0">
                    <a:effectLst/>
                  </a:rPr>
                  <a:t>)</a:t>
                </a:r>
                <a:endParaRPr lang="en-US" sz="1000" dirty="0" smtClean="0">
                  <a:effectLst/>
                </a:endParaRPr>
              </a:p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1" i="0" u="none" strike="noStrike" kern="1200" baseline="0">
                    <a:solidFill>
                      <a:prstClr val="black"/>
                    </a:solidFill>
                    <a:latin typeface="+mn-lt"/>
                    <a:ea typeface="+mn-ea"/>
                    <a:cs typeface="+mn-cs"/>
                  </a:defRPr>
                </a:pPr>
                <a:endParaRPr lang="en-US" sz="1000" dirty="0"/>
              </a:p>
            </c:rich>
          </c:tx>
          <c:layout/>
          <c:overlay val="0"/>
        </c:title>
        <c:numFmt formatCode="#.00" sourceLinked="1"/>
        <c:majorTickMark val="out"/>
        <c:minorTickMark val="none"/>
        <c:tickLblPos val="nextTo"/>
        <c:crossAx val="74511104"/>
        <c:crosses val="autoZero"/>
        <c:crossBetween val="midCat"/>
      </c:valAx>
      <c:valAx>
        <c:axId val="74511104"/>
        <c:scaling>
          <c:orientation val="minMax"/>
        </c:scaling>
        <c:delete val="0"/>
        <c:axPos val="l"/>
        <c:majorGridlines/>
        <c:min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% </a:t>
                </a:r>
                <a:r>
                  <a:rPr lang="en-US" dirty="0" smtClean="0"/>
                  <a:t>methylation</a:t>
                </a:r>
                <a:endParaRPr lang="en-U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74488448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V$1</c:f>
              <c:strCache>
                <c:ptCount val="1"/>
                <c:pt idx="0">
                  <c:v>hFKint2Region4Pyro1CpG3</c:v>
                </c:pt>
              </c:strCache>
            </c:strRef>
          </c:tx>
          <c:spPr>
            <a:ln w="47625">
              <a:noFill/>
            </a:ln>
          </c:spPr>
          <c:trendline>
            <c:trendlineType val="linear"/>
            <c:dispRSqr val="1"/>
            <c:dispEq val="1"/>
            <c:trendlineLbl>
              <c:layout>
                <c:manualLayout>
                  <c:x val="0.21851902887139099"/>
                  <c:y val="0.59060659084281097"/>
                </c:manualLayout>
              </c:layout>
              <c:numFmt formatCode="General" sourceLinked="0"/>
            </c:trendlineLbl>
          </c:trendline>
          <c:xVal>
            <c:numRef>
              <c:f>Sheet1!$H$2:$H$129</c:f>
              <c:numCache>
                <c:formatCode>#.00</c:formatCode>
                <c:ptCount val="128"/>
                <c:pt idx="0">
                  <c:v>111.76</c:v>
                </c:pt>
                <c:pt idx="1">
                  <c:v>132.08000000000001</c:v>
                </c:pt>
                <c:pt idx="2">
                  <c:v>93.98</c:v>
                </c:pt>
                <c:pt idx="4">
                  <c:v>90.6</c:v>
                </c:pt>
                <c:pt idx="6">
                  <c:v>87</c:v>
                </c:pt>
                <c:pt idx="8">
                  <c:v>107</c:v>
                </c:pt>
                <c:pt idx="9">
                  <c:v>110</c:v>
                </c:pt>
                <c:pt idx="11">
                  <c:v>131</c:v>
                </c:pt>
                <c:pt idx="16">
                  <c:v>91.44</c:v>
                </c:pt>
                <c:pt idx="21">
                  <c:v>101.6</c:v>
                </c:pt>
                <c:pt idx="22">
                  <c:v>106.68</c:v>
                </c:pt>
                <c:pt idx="23">
                  <c:v>91.44</c:v>
                </c:pt>
                <c:pt idx="24">
                  <c:v>106.68</c:v>
                </c:pt>
                <c:pt idx="25">
                  <c:v>86.4</c:v>
                </c:pt>
                <c:pt idx="26">
                  <c:v>104.1</c:v>
                </c:pt>
                <c:pt idx="27">
                  <c:v>94</c:v>
                </c:pt>
                <c:pt idx="28">
                  <c:v>110</c:v>
                </c:pt>
                <c:pt idx="30">
                  <c:v>116</c:v>
                </c:pt>
                <c:pt idx="31">
                  <c:v>127</c:v>
                </c:pt>
                <c:pt idx="32">
                  <c:v>149</c:v>
                </c:pt>
                <c:pt idx="33">
                  <c:v>86.36</c:v>
                </c:pt>
                <c:pt idx="34">
                  <c:v>76.2</c:v>
                </c:pt>
                <c:pt idx="35">
                  <c:v>147.30000000000001</c:v>
                </c:pt>
                <c:pt idx="36">
                  <c:v>115</c:v>
                </c:pt>
                <c:pt idx="37">
                  <c:v>110</c:v>
                </c:pt>
                <c:pt idx="40">
                  <c:v>165</c:v>
                </c:pt>
                <c:pt idx="41">
                  <c:v>79</c:v>
                </c:pt>
                <c:pt idx="42">
                  <c:v>106</c:v>
                </c:pt>
                <c:pt idx="43">
                  <c:v>106</c:v>
                </c:pt>
                <c:pt idx="44">
                  <c:v>148</c:v>
                </c:pt>
                <c:pt idx="45">
                  <c:v>107</c:v>
                </c:pt>
                <c:pt idx="46">
                  <c:v>101.6</c:v>
                </c:pt>
                <c:pt idx="47">
                  <c:v>101.6</c:v>
                </c:pt>
                <c:pt idx="48">
                  <c:v>106.68</c:v>
                </c:pt>
                <c:pt idx="51">
                  <c:v>152.4</c:v>
                </c:pt>
                <c:pt idx="53">
                  <c:v>91.4</c:v>
                </c:pt>
                <c:pt idx="54">
                  <c:v>83.8</c:v>
                </c:pt>
                <c:pt idx="55">
                  <c:v>127</c:v>
                </c:pt>
                <c:pt idx="56">
                  <c:v>127</c:v>
                </c:pt>
                <c:pt idx="57">
                  <c:v>86.4</c:v>
                </c:pt>
                <c:pt idx="58">
                  <c:v>129.5</c:v>
                </c:pt>
                <c:pt idx="59">
                  <c:v>86.4</c:v>
                </c:pt>
                <c:pt idx="60">
                  <c:v>91.4</c:v>
                </c:pt>
                <c:pt idx="61">
                  <c:v>109.2</c:v>
                </c:pt>
                <c:pt idx="62">
                  <c:v>86.4</c:v>
                </c:pt>
                <c:pt idx="63">
                  <c:v>86.4</c:v>
                </c:pt>
                <c:pt idx="64">
                  <c:v>96.5</c:v>
                </c:pt>
                <c:pt idx="65">
                  <c:v>106.7</c:v>
                </c:pt>
                <c:pt idx="66">
                  <c:v>137.19999999999999</c:v>
                </c:pt>
                <c:pt idx="67">
                  <c:v>76.2</c:v>
                </c:pt>
                <c:pt idx="68">
                  <c:v>124.5</c:v>
                </c:pt>
                <c:pt idx="69">
                  <c:v>91</c:v>
                </c:pt>
                <c:pt idx="70">
                  <c:v>118</c:v>
                </c:pt>
                <c:pt idx="71">
                  <c:v>138</c:v>
                </c:pt>
                <c:pt idx="72">
                  <c:v>69.2</c:v>
                </c:pt>
                <c:pt idx="73">
                  <c:v>104</c:v>
                </c:pt>
                <c:pt idx="74">
                  <c:v>125</c:v>
                </c:pt>
                <c:pt idx="75">
                  <c:v>89</c:v>
                </c:pt>
                <c:pt idx="76">
                  <c:v>97</c:v>
                </c:pt>
                <c:pt idx="77">
                  <c:v>135</c:v>
                </c:pt>
                <c:pt idx="78">
                  <c:v>128</c:v>
                </c:pt>
                <c:pt idx="79">
                  <c:v>93</c:v>
                </c:pt>
                <c:pt idx="80">
                  <c:v>129</c:v>
                </c:pt>
                <c:pt idx="81">
                  <c:v>144</c:v>
                </c:pt>
                <c:pt idx="84">
                  <c:v>103</c:v>
                </c:pt>
                <c:pt idx="85">
                  <c:v>102</c:v>
                </c:pt>
                <c:pt idx="86">
                  <c:v>93</c:v>
                </c:pt>
                <c:pt idx="87">
                  <c:v>150</c:v>
                </c:pt>
                <c:pt idx="88">
                  <c:v>105</c:v>
                </c:pt>
                <c:pt idx="89">
                  <c:v>126</c:v>
                </c:pt>
                <c:pt idx="90">
                  <c:v>76.2</c:v>
                </c:pt>
                <c:pt idx="91">
                  <c:v>96.52</c:v>
                </c:pt>
                <c:pt idx="92">
                  <c:v>134</c:v>
                </c:pt>
                <c:pt idx="93">
                  <c:v>155</c:v>
                </c:pt>
                <c:pt idx="94">
                  <c:v>89</c:v>
                </c:pt>
                <c:pt idx="95">
                  <c:v>80</c:v>
                </c:pt>
                <c:pt idx="96">
                  <c:v>99</c:v>
                </c:pt>
                <c:pt idx="97">
                  <c:v>137</c:v>
                </c:pt>
                <c:pt idx="98">
                  <c:v>87</c:v>
                </c:pt>
                <c:pt idx="99">
                  <c:v>116</c:v>
                </c:pt>
                <c:pt idx="100">
                  <c:v>144</c:v>
                </c:pt>
                <c:pt idx="101">
                  <c:v>89</c:v>
                </c:pt>
                <c:pt idx="102">
                  <c:v>110</c:v>
                </c:pt>
                <c:pt idx="103">
                  <c:v>112</c:v>
                </c:pt>
                <c:pt idx="104">
                  <c:v>110</c:v>
                </c:pt>
                <c:pt idx="105">
                  <c:v>100.5</c:v>
                </c:pt>
                <c:pt idx="107">
                  <c:v>74</c:v>
                </c:pt>
                <c:pt idx="108">
                  <c:v>90</c:v>
                </c:pt>
                <c:pt idx="109">
                  <c:v>99</c:v>
                </c:pt>
                <c:pt idx="110">
                  <c:v>149</c:v>
                </c:pt>
                <c:pt idx="111">
                  <c:v>99</c:v>
                </c:pt>
                <c:pt idx="112">
                  <c:v>107</c:v>
                </c:pt>
                <c:pt idx="113">
                  <c:v>113</c:v>
                </c:pt>
                <c:pt idx="114">
                  <c:v>112</c:v>
                </c:pt>
                <c:pt idx="115">
                  <c:v>94</c:v>
                </c:pt>
                <c:pt idx="116">
                  <c:v>110</c:v>
                </c:pt>
                <c:pt idx="117">
                  <c:v>90</c:v>
                </c:pt>
                <c:pt idx="118">
                  <c:v>102</c:v>
                </c:pt>
                <c:pt idx="119">
                  <c:v>86</c:v>
                </c:pt>
                <c:pt idx="120">
                  <c:v>94</c:v>
                </c:pt>
                <c:pt idx="121">
                  <c:v>100</c:v>
                </c:pt>
                <c:pt idx="122">
                  <c:v>164</c:v>
                </c:pt>
              </c:numCache>
            </c:numRef>
          </c:xVal>
          <c:yVal>
            <c:numRef>
              <c:f>Sheet1!$V$2:$V$129</c:f>
              <c:numCache>
                <c:formatCode>General</c:formatCode>
                <c:ptCount val="128"/>
                <c:pt idx="6" formatCode="#.00">
                  <c:v>66.669999999999973</c:v>
                </c:pt>
                <c:pt idx="9" formatCode="#.00">
                  <c:v>63.79</c:v>
                </c:pt>
                <c:pt idx="10" formatCode="#.00">
                  <c:v>68.87</c:v>
                </c:pt>
                <c:pt idx="11" formatCode="#.00">
                  <c:v>69.89</c:v>
                </c:pt>
                <c:pt idx="13" formatCode="#.00">
                  <c:v>67.290000000000006</c:v>
                </c:pt>
                <c:pt idx="14" formatCode="#.00">
                  <c:v>68.790000000000006</c:v>
                </c:pt>
                <c:pt idx="16" formatCode="#.00">
                  <c:v>68.2</c:v>
                </c:pt>
                <c:pt idx="29" formatCode="#.00">
                  <c:v>65.8</c:v>
                </c:pt>
                <c:pt idx="30" formatCode="#.00">
                  <c:v>66.959999999999994</c:v>
                </c:pt>
                <c:pt idx="31" formatCode="#.00">
                  <c:v>64.260000000000005</c:v>
                </c:pt>
                <c:pt idx="32" formatCode="#.00">
                  <c:v>67.430000000000007</c:v>
                </c:pt>
                <c:pt idx="35" formatCode="#.00">
                  <c:v>70.34</c:v>
                </c:pt>
                <c:pt idx="36" formatCode="#.00">
                  <c:v>64.02</c:v>
                </c:pt>
                <c:pt idx="37" formatCode="#.00">
                  <c:v>66.569999999999993</c:v>
                </c:pt>
                <c:pt idx="38" formatCode="#.00">
                  <c:v>65.02</c:v>
                </c:pt>
                <c:pt idx="39" formatCode="#.00">
                  <c:v>64.849999999999994</c:v>
                </c:pt>
                <c:pt idx="40" formatCode="#.00">
                  <c:v>69.760000000000005</c:v>
                </c:pt>
                <c:pt idx="41" formatCode="#.00">
                  <c:v>64.47</c:v>
                </c:pt>
                <c:pt idx="42" formatCode="#.00">
                  <c:v>68.2</c:v>
                </c:pt>
                <c:pt idx="43" formatCode="#.00">
                  <c:v>66.169999999999973</c:v>
                </c:pt>
                <c:pt idx="44" formatCode="#.00">
                  <c:v>66.94</c:v>
                </c:pt>
                <c:pt idx="45" formatCode="#.00">
                  <c:v>66.11</c:v>
                </c:pt>
                <c:pt idx="46" formatCode="#.00">
                  <c:v>65.459999999999994</c:v>
                </c:pt>
                <c:pt idx="47" formatCode="#.00">
                  <c:v>65.150000000000006</c:v>
                </c:pt>
                <c:pt idx="48" formatCode="#.00">
                  <c:v>64.41</c:v>
                </c:pt>
                <c:pt idx="50" formatCode="#.00">
                  <c:v>69.099999999999994</c:v>
                </c:pt>
                <c:pt idx="51" formatCode="#.00">
                  <c:v>67.41</c:v>
                </c:pt>
                <c:pt idx="52" formatCode="#.00">
                  <c:v>63.24</c:v>
                </c:pt>
                <c:pt idx="53" formatCode="#.00">
                  <c:v>67.44</c:v>
                </c:pt>
                <c:pt idx="54" formatCode="#.00">
                  <c:v>66.05</c:v>
                </c:pt>
                <c:pt idx="55" formatCode="#.00">
                  <c:v>65.06</c:v>
                </c:pt>
                <c:pt idx="56" formatCode="#.00">
                  <c:v>66.08</c:v>
                </c:pt>
                <c:pt idx="57" formatCode="#.00">
                  <c:v>65.62</c:v>
                </c:pt>
                <c:pt idx="58" formatCode="#.00">
                  <c:v>65.77</c:v>
                </c:pt>
                <c:pt idx="59" formatCode="#.00">
                  <c:v>66.169999999999973</c:v>
                </c:pt>
                <c:pt idx="60" formatCode="#.00">
                  <c:v>67.2</c:v>
                </c:pt>
                <c:pt idx="61" formatCode="#.00">
                  <c:v>67.62</c:v>
                </c:pt>
                <c:pt idx="63" formatCode="#.00">
                  <c:v>65.489999999999995</c:v>
                </c:pt>
                <c:pt idx="64" formatCode="#.00">
                  <c:v>63.59</c:v>
                </c:pt>
                <c:pt idx="65" formatCode="#.00">
                  <c:v>67.540000000000006</c:v>
                </c:pt>
                <c:pt idx="66" formatCode="#.00">
                  <c:v>67.38</c:v>
                </c:pt>
                <c:pt idx="67" formatCode="#.00">
                  <c:v>66.88</c:v>
                </c:pt>
                <c:pt idx="68" formatCode="#.00">
                  <c:v>68.38</c:v>
                </c:pt>
                <c:pt idx="69" formatCode="#.00">
                  <c:v>66.94</c:v>
                </c:pt>
                <c:pt idx="70" formatCode="#.00">
                  <c:v>67.42</c:v>
                </c:pt>
                <c:pt idx="71" formatCode="#.00">
                  <c:v>68.09</c:v>
                </c:pt>
                <c:pt idx="72" formatCode="#.00">
                  <c:v>65.959999999999994</c:v>
                </c:pt>
                <c:pt idx="73" formatCode="#.00">
                  <c:v>64.959999999999994</c:v>
                </c:pt>
                <c:pt idx="74" formatCode="#.00">
                  <c:v>65.81</c:v>
                </c:pt>
                <c:pt idx="75" formatCode="#.00">
                  <c:v>68.62</c:v>
                </c:pt>
                <c:pt idx="76" formatCode="#.00">
                  <c:v>68.09</c:v>
                </c:pt>
                <c:pt idx="77" formatCode="#.00">
                  <c:v>65.599999999999994</c:v>
                </c:pt>
                <c:pt idx="78" formatCode="#.00">
                  <c:v>71.56</c:v>
                </c:pt>
                <c:pt idx="79" formatCode="#.00">
                  <c:v>65.91</c:v>
                </c:pt>
                <c:pt idx="80" formatCode="#.00">
                  <c:v>66.39</c:v>
                </c:pt>
                <c:pt idx="81" formatCode="#.00">
                  <c:v>64.83</c:v>
                </c:pt>
                <c:pt idx="82" formatCode="#.00">
                  <c:v>64.42</c:v>
                </c:pt>
                <c:pt idx="83" formatCode="#.00">
                  <c:v>66.150000000000006</c:v>
                </c:pt>
                <c:pt idx="84" formatCode="#.00">
                  <c:v>64.48</c:v>
                </c:pt>
                <c:pt idx="85" formatCode="#.00">
                  <c:v>65.27</c:v>
                </c:pt>
                <c:pt idx="86" formatCode="#.00">
                  <c:v>65.11</c:v>
                </c:pt>
                <c:pt idx="87" formatCode="#.00">
                  <c:v>70.3</c:v>
                </c:pt>
                <c:pt idx="88" formatCode="#.00">
                  <c:v>65.72</c:v>
                </c:pt>
                <c:pt idx="89" formatCode="#.00">
                  <c:v>65.8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9586432"/>
        <c:axId val="79588352"/>
      </c:scatterChart>
      <c:valAx>
        <c:axId val="79586432"/>
        <c:scaling>
          <c:orientation val="minMax"/>
          <c:min val="6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Waist circumference</a:t>
                </a:r>
                <a:r>
                  <a:rPr lang="en-US" baseline="0"/>
                  <a:t> (cm)</a:t>
                </a:r>
                <a:endParaRPr lang="en-US"/>
              </a:p>
            </c:rich>
          </c:tx>
          <c:layout/>
          <c:overlay val="0"/>
        </c:title>
        <c:numFmt formatCode="#.00" sourceLinked="1"/>
        <c:majorTickMark val="out"/>
        <c:minorTickMark val="none"/>
        <c:tickLblPos val="nextTo"/>
        <c:crossAx val="79588352"/>
        <c:crosses val="autoZero"/>
        <c:crossBetween val="midCat"/>
      </c:valAx>
      <c:valAx>
        <c:axId val="79588352"/>
        <c:scaling>
          <c:orientation val="minMax"/>
        </c:scaling>
        <c:delete val="0"/>
        <c:axPos val="l"/>
        <c:majorGridlines/>
        <c:min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% methylatio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7958643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AF31-F79A-6D4B-A266-692CB43AD370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A960C-B51C-5740-8193-724F7C5F5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8875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AF31-F79A-6D4B-A266-692CB43AD370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A960C-B51C-5740-8193-724F7C5F5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3744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AF31-F79A-6D4B-A266-692CB43AD370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A960C-B51C-5740-8193-724F7C5F5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45816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AF31-F79A-6D4B-A266-692CB43AD370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A960C-B51C-5740-8193-724F7C5F5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1274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AF31-F79A-6D4B-A266-692CB43AD370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A960C-B51C-5740-8193-724F7C5F5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01373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AF31-F79A-6D4B-A266-692CB43AD370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A960C-B51C-5740-8193-724F7C5F5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35336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AF31-F79A-6D4B-A266-692CB43AD370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A960C-B51C-5740-8193-724F7C5F5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47132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AF31-F79A-6D4B-A266-692CB43AD370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A960C-B51C-5740-8193-724F7C5F5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7283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AF31-F79A-6D4B-A266-692CB43AD370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A960C-B51C-5740-8193-724F7C5F5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27136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AF31-F79A-6D4B-A266-692CB43AD370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A960C-B51C-5740-8193-724F7C5F5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84343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AF31-F79A-6D4B-A266-692CB43AD370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A960C-B51C-5740-8193-724F7C5F5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14979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B8AF31-F79A-6D4B-A266-692CB43AD370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6A960C-B51C-5740-8193-724F7C5F5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5096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035825" y="919083"/>
            <a:ext cx="6976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8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CpG9</a:t>
            </a:r>
            <a:endParaRPr lang="en-US" dirty="0"/>
          </a:p>
        </p:txBody>
      </p:sp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51519755"/>
              </p:ext>
            </p:extLst>
          </p:nvPr>
        </p:nvGraphicFramePr>
        <p:xfrm>
          <a:off x="188605" y="1172876"/>
          <a:ext cx="4149220" cy="22406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16444796"/>
              </p:ext>
            </p:extLst>
          </p:nvPr>
        </p:nvGraphicFramePr>
        <p:xfrm>
          <a:off x="188606" y="3623027"/>
          <a:ext cx="4149219" cy="21979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Rectangle 8"/>
          <p:cNvSpPr/>
          <p:nvPr/>
        </p:nvSpPr>
        <p:spPr>
          <a:xfrm>
            <a:off x="6597599" y="934618"/>
            <a:ext cx="6976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8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CpG7</a:t>
            </a:r>
            <a:endParaRPr lang="en-US" dirty="0"/>
          </a:p>
        </p:txBody>
      </p:sp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5596330"/>
              </p:ext>
            </p:extLst>
          </p:nvPr>
        </p:nvGraphicFramePr>
        <p:xfrm>
          <a:off x="4768190" y="1172876"/>
          <a:ext cx="4045761" cy="22406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08769274"/>
              </p:ext>
            </p:extLst>
          </p:nvPr>
        </p:nvGraphicFramePr>
        <p:xfrm>
          <a:off x="4768190" y="3630590"/>
          <a:ext cx="4045761" cy="22267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0" y="3112762"/>
            <a:ext cx="11266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N=60</a:t>
            </a:r>
            <a:endParaRPr lang="en-US" sz="12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29490" y="5498385"/>
            <a:ext cx="11266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N=54</a:t>
            </a:r>
            <a:endParaRPr lang="en-US" sz="12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4638615" y="3121753"/>
            <a:ext cx="11266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N=64</a:t>
            </a:r>
            <a:endParaRPr lang="en-US" sz="1200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4668105" y="5507376"/>
            <a:ext cx="11266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N=54</a:t>
            </a:r>
            <a:endParaRPr lang="en-US" sz="12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187356" y="972199"/>
            <a:ext cx="3122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25" name="TextBox 24"/>
          <p:cNvSpPr txBox="1"/>
          <p:nvPr/>
        </p:nvSpPr>
        <p:spPr>
          <a:xfrm>
            <a:off x="4720581" y="1023208"/>
            <a:ext cx="3122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83626" y="3440103"/>
            <a:ext cx="3122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4724672" y="3484259"/>
            <a:ext cx="3122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cxnSp>
        <p:nvCxnSpPr>
          <p:cNvPr id="30" name="Straight Connector 29"/>
          <p:cNvCxnSpPr/>
          <p:nvPr/>
        </p:nvCxnSpPr>
        <p:spPr>
          <a:xfrm flipV="1">
            <a:off x="5908242" y="3794495"/>
            <a:ext cx="0" cy="1458880"/>
          </a:xfrm>
          <a:prstGeom prst="line">
            <a:avLst/>
          </a:prstGeom>
          <a:ln w="28575" cmpd="sng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 flipV="1">
            <a:off x="6254875" y="3797485"/>
            <a:ext cx="0" cy="1458880"/>
          </a:xfrm>
          <a:prstGeom prst="line">
            <a:avLst/>
          </a:prstGeom>
          <a:ln w="28575" cmpd="sng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 flipV="1">
            <a:off x="6340034" y="1332776"/>
            <a:ext cx="0" cy="1458880"/>
          </a:xfrm>
          <a:prstGeom prst="line">
            <a:avLst/>
          </a:prstGeom>
          <a:ln w="28575" cmpd="sng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V="1">
            <a:off x="1621972" y="1341531"/>
            <a:ext cx="0" cy="1458880"/>
          </a:xfrm>
          <a:prstGeom prst="line">
            <a:avLst/>
          </a:prstGeom>
          <a:ln w="28575" cmpd="sng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 flipV="1">
            <a:off x="2127947" y="3776004"/>
            <a:ext cx="0" cy="1458880"/>
          </a:xfrm>
          <a:prstGeom prst="line">
            <a:avLst/>
          </a:prstGeom>
          <a:ln w="28575" cmpd="sng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342382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4</Words>
  <Application>Microsoft Office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in Ortiz</dc:creator>
  <cp:lastModifiedBy>Sevilla, Hernando Jr.</cp:lastModifiedBy>
  <cp:revision>7</cp:revision>
  <dcterms:created xsi:type="dcterms:W3CDTF">2017-10-31T14:06:41Z</dcterms:created>
  <dcterms:modified xsi:type="dcterms:W3CDTF">2018-06-14T02:54:45Z</dcterms:modified>
</cp:coreProperties>
</file>